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699250" cy="4392613"/>
  <p:notesSz cx="6781800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1C7775-60F0-42A7-83A4-0652B478439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34800" y="175680"/>
            <a:ext cx="6027840" cy="73188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ctr">
            <a:noAutofit/>
          </a:bodyPr>
          <a:p>
            <a:pPr indent="0" algn="ctr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34800" y="1025640"/>
            <a:ext cx="602784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34800" y="2539800"/>
            <a:ext cx="602784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14AC97-719A-4D83-AC72-F8CF4E6568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34800" y="175680"/>
            <a:ext cx="6027840" cy="73188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ctr">
            <a:noAutofit/>
          </a:bodyPr>
          <a:p>
            <a:pPr indent="0" algn="ctr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34800" y="1025640"/>
            <a:ext cx="294156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423960" y="1025640"/>
            <a:ext cx="294156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34800" y="2539800"/>
            <a:ext cx="294156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423960" y="2539800"/>
            <a:ext cx="294156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3CDDAE-8765-4F92-9E1F-49FE6CF9912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34800" y="175680"/>
            <a:ext cx="6027840" cy="73188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ctr">
            <a:noAutofit/>
          </a:bodyPr>
          <a:p>
            <a:pPr indent="0" algn="ctr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34800" y="1025640"/>
            <a:ext cx="194076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373120" y="1025640"/>
            <a:ext cx="194076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11080" y="1025640"/>
            <a:ext cx="194076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34800" y="2539800"/>
            <a:ext cx="194076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373120" y="2539800"/>
            <a:ext cx="194076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11080" y="2539800"/>
            <a:ext cx="194076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0B8ACD-63B0-4E26-89E6-04C650D8CBD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34800" y="175680"/>
            <a:ext cx="6027840" cy="73188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ctr">
            <a:noAutofit/>
          </a:bodyPr>
          <a:p>
            <a:pPr indent="0" algn="ctr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34800" y="1025640"/>
            <a:ext cx="6027840" cy="2898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24"/>
              </a:spcBef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DB35C-E49A-4A90-8700-5E9AF52C4A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34800" y="175680"/>
            <a:ext cx="6027840" cy="73188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ctr">
            <a:noAutofit/>
          </a:bodyPr>
          <a:p>
            <a:pPr indent="0" algn="ctr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34800" y="1025640"/>
            <a:ext cx="6027840" cy="289872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8A3EAC-FDA1-4CBC-B5E2-DD51F71A47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34800" y="175680"/>
            <a:ext cx="6027840" cy="73188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ctr">
            <a:noAutofit/>
          </a:bodyPr>
          <a:p>
            <a:pPr indent="0" algn="ctr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34800" y="1025640"/>
            <a:ext cx="2941560" cy="289872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423960" y="1025640"/>
            <a:ext cx="2941560" cy="289872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4BE8B8-9ABD-42A5-A577-273AE4BEBA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34800" y="175680"/>
            <a:ext cx="6027840" cy="73188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ctr">
            <a:noAutofit/>
          </a:bodyPr>
          <a:p>
            <a:pPr indent="0" algn="ctr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B8923B-0460-4C6D-B7B6-08090338F8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34800" y="175680"/>
            <a:ext cx="6027840" cy="3393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24"/>
              </a:spcBef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B7CDDB-5937-44BF-BD91-2360A7D2D5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34800" y="175680"/>
            <a:ext cx="6027840" cy="73188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ctr">
            <a:noAutofit/>
          </a:bodyPr>
          <a:p>
            <a:pPr indent="0" algn="ctr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34800" y="1025640"/>
            <a:ext cx="294156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423960" y="1025640"/>
            <a:ext cx="2941560" cy="289872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34800" y="2539800"/>
            <a:ext cx="294156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DE64CA-B721-4313-A29B-51E891F3BA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34800" y="175680"/>
            <a:ext cx="6027840" cy="73188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ctr">
            <a:noAutofit/>
          </a:bodyPr>
          <a:p>
            <a:pPr indent="0" algn="ctr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34800" y="1025640"/>
            <a:ext cx="2941560" cy="289872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423960" y="1025640"/>
            <a:ext cx="294156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423960" y="2539800"/>
            <a:ext cx="294156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7EE81B-EC59-44F0-BADC-3CB12566EB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34800" y="175680"/>
            <a:ext cx="6027840" cy="73188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ctr">
            <a:noAutofit/>
          </a:bodyPr>
          <a:p>
            <a:pPr indent="0" algn="ctr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34800" y="1025640"/>
            <a:ext cx="294156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423960" y="1025640"/>
            <a:ext cx="294156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34800" y="2539800"/>
            <a:ext cx="6027840" cy="138240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3921DF-BC06-4FEF-8839-F19E4CF963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34800" y="175680"/>
            <a:ext cx="6027840" cy="73188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ctr">
            <a:noAutofit/>
          </a:bodyPr>
          <a:p>
            <a:pPr indent="0" algn="ctr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34800" y="1025640"/>
            <a:ext cx="6027840" cy="289872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rmAutofit/>
          </a:bodyPr>
          <a:p>
            <a:pPr marL="219240" indent="-21924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473040" indent="-18252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727200" indent="-14472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019160" indent="-14616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311120" indent="-14580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311120" indent="-14580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311120" indent="-14580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34800" y="4000320"/>
            <a:ext cx="1563840" cy="30636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Autofit/>
          </a:bodyPr>
          <a:lstStyle>
            <a:lvl1pPr indent="0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  <a:defRPr b="0" lang="en-GB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88880" y="4000320"/>
            <a:ext cx="2119320" cy="30636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Autofit/>
          </a:bodyPr>
          <a:lstStyle>
            <a:lvl1pPr indent="0" algn="ctr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  <a:defRPr b="0" lang="en-GB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798800" y="4000320"/>
            <a:ext cx="1563480" cy="306360"/>
          </a:xfrm>
          <a:prstGeom prst="rect">
            <a:avLst/>
          </a:prstGeom>
          <a:noFill/>
          <a:ln w="0">
            <a:noFill/>
          </a:ln>
        </p:spPr>
        <p:txBody>
          <a:bodyPr lIns="58320" rIns="58320" tIns="29160" bIns="29160" anchor="t">
            <a:noAutofit/>
          </a:bodyPr>
          <a:lstStyle>
            <a:lvl1pPr indent="0" algn="r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  <a:defRPr b="0" lang="en-GB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582480"/>
                <a:tab algn="l" pos="1165320"/>
                <a:tab algn="l" pos="1747800"/>
                <a:tab algn="l" pos="2330280"/>
                <a:tab algn="l" pos="2913120"/>
                <a:tab algn="l" pos="3495600"/>
                <a:tab algn="l" pos="4078440"/>
                <a:tab algn="l" pos="4660920"/>
                <a:tab algn="l" pos="5243400"/>
                <a:tab algn="l" pos="5826240"/>
                <a:tab algn="l" pos="6408720"/>
                <a:tab algn="l" pos="6991200"/>
                <a:tab algn="l" pos="7574040"/>
                <a:tab algn="l" pos="8156520"/>
                <a:tab algn="l" pos="8739360"/>
                <a:tab algn="l" pos="9321840"/>
                <a:tab algn="l" pos="9904320"/>
                <a:tab algn="l" pos="10487160"/>
              </a:tabLst>
            </a:pPr>
            <a:fld id="{F5907413-708C-44E0-B91B-A0E88BABF587}" type="slidenum">
              <a:rPr b="0" lang="en-GB" sz="9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00040" y="3659040"/>
            <a:ext cx="249120" cy="180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79240" y="34750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flipH="1">
            <a:off x="5422680" y="1913040"/>
            <a:ext cx="585720" cy="5688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052320" y="1855800"/>
            <a:ext cx="319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flipH="1">
            <a:off x="5676840" y="2100240"/>
            <a:ext cx="465120" cy="10332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6167520" y="2062080"/>
            <a:ext cx="403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flipH="1">
            <a:off x="5901840" y="2344680"/>
            <a:ext cx="249480" cy="8100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6194880" y="2293920"/>
            <a:ext cx="447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Opossum TLR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flipH="1">
            <a:off x="6184800" y="2532240"/>
            <a:ext cx="98640" cy="2664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0160" bIns="-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6327360" y="248760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H="1" flipV="1">
            <a:off x="6184800" y="2558880"/>
            <a:ext cx="82800" cy="8424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6297840" y="2622600"/>
            <a:ext cx="255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TLR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H="1">
            <a:off x="5959440" y="2558880"/>
            <a:ext cx="225360" cy="6696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H="1" flipV="1">
            <a:off x="5987520" y="2696760"/>
            <a:ext cx="142920" cy="6372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6165360" y="273672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H="1" flipV="1">
            <a:off x="5983200" y="2798280"/>
            <a:ext cx="115920" cy="7956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6132960" y="2854440"/>
            <a:ext cx="30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ow TLR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H="1" flipV="1">
            <a:off x="5983200" y="2798280"/>
            <a:ext cx="31680" cy="21924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6058080" y="3011400"/>
            <a:ext cx="2901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og TLR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5983200" y="2697120"/>
            <a:ext cx="4680" cy="10152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H="1" flipV="1">
            <a:off x="5959080" y="2625840"/>
            <a:ext cx="28440" cy="7128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H="1" flipV="1">
            <a:off x="5901840" y="2425680"/>
            <a:ext cx="57240" cy="20016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H="1" flipV="1">
            <a:off x="5676840" y="2203200"/>
            <a:ext cx="225360" cy="22212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H="1" flipV="1">
            <a:off x="5422680" y="1969560"/>
            <a:ext cx="253800" cy="23364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H="1">
            <a:off x="4952880" y="1969920"/>
            <a:ext cx="470160" cy="1620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600" bIns="-30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H="1" flipV="1">
            <a:off x="5195520" y="2324160"/>
            <a:ext cx="452520" cy="65232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rot="3141600">
            <a:off x="5595840" y="3100320"/>
            <a:ext cx="319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flipH="1" flipV="1">
            <a:off x="5160960" y="2739600"/>
            <a:ext cx="372960" cy="40500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rot="2609400">
            <a:off x="5472720" y="3313080"/>
            <a:ext cx="503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H="1" flipV="1">
            <a:off x="5095800" y="3035160"/>
            <a:ext cx="331920" cy="30024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2416200">
            <a:off x="5389920" y="3467160"/>
            <a:ext cx="447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Opossum TLR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flipH="1" flipV="1">
            <a:off x="5000760" y="3339720"/>
            <a:ext cx="303120" cy="21924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895400">
            <a:off x="5309280" y="362592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flipH="1" flipV="1">
            <a:off x="4957920" y="3487680"/>
            <a:ext cx="188640" cy="23328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rot="2560800">
            <a:off x="5105880" y="383868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H="1" flipV="1">
            <a:off x="4871520" y="3612960"/>
            <a:ext cx="95400" cy="29340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rot="4432200">
            <a:off x="4880160" y="4021200"/>
            <a:ext cx="266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 TLR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V="1">
            <a:off x="4749840" y="3612960"/>
            <a:ext cx="122040" cy="19980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rot="18243600">
            <a:off x="4511160" y="3930480"/>
            <a:ext cx="2901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og TLR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flipV="1">
            <a:off x="4871880" y="3487320"/>
            <a:ext cx="86040" cy="12564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flipV="1">
            <a:off x="4957920" y="3340080"/>
            <a:ext cx="42840" cy="14760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V="1">
            <a:off x="5000760" y="3034800"/>
            <a:ext cx="95040" cy="30492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5095800" y="2739960"/>
            <a:ext cx="65160" cy="29520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flipV="1">
            <a:off x="5160960" y="2323800"/>
            <a:ext cx="34920" cy="41580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H="1" flipV="1">
            <a:off x="4952520" y="1985760"/>
            <a:ext cx="243000" cy="33804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flipH="1" flipV="1">
            <a:off x="4420800" y="1982520"/>
            <a:ext cx="531720" cy="32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flipH="1" flipV="1">
            <a:off x="4514400" y="2431800"/>
            <a:ext cx="88920" cy="70956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rot="4921800">
            <a:off x="4389840" y="3382920"/>
            <a:ext cx="503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flipH="1" flipV="1">
            <a:off x="4404960" y="2847600"/>
            <a:ext cx="27000" cy="67788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rot="5226600">
            <a:off x="4226400" y="3737520"/>
            <a:ext cx="439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ebrafish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flipH="1" flipV="1">
            <a:off x="4138560" y="3225600"/>
            <a:ext cx="55440" cy="47916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rot="4958400">
            <a:off x="4057560" y="3846240"/>
            <a:ext cx="319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3956040" y="3527280"/>
            <a:ext cx="1440" cy="180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rot="16929600">
            <a:off x="3615480" y="3770280"/>
            <a:ext cx="509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Seabream TLR9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flipV="1">
            <a:off x="3948120" y="3526920"/>
            <a:ext cx="7920" cy="972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 rot="16284600">
            <a:off x="3715560" y="3765240"/>
            <a:ext cx="509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Seabream TLR9B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flipV="1">
            <a:off x="3956040" y="3225600"/>
            <a:ext cx="182520" cy="30132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flipV="1">
            <a:off x="4138560" y="2847960"/>
            <a:ext cx="266760" cy="37800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flipV="1">
            <a:off x="4405320" y="2431800"/>
            <a:ext cx="109440" cy="41580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flipH="1" flipV="1">
            <a:off x="4421160" y="1982880"/>
            <a:ext cx="93600" cy="44928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flipH="1" flipV="1">
            <a:off x="3928680" y="1943280"/>
            <a:ext cx="492120" cy="3960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flipV="1">
            <a:off x="3886200" y="2567160"/>
            <a:ext cx="46080" cy="46008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 rot="16279200">
            <a:off x="3654720" y="3244320"/>
            <a:ext cx="447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Opossum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flipV="1">
            <a:off x="3805200" y="3225600"/>
            <a:ext cx="1800" cy="10764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 rot="16071000">
            <a:off x="3620880" y="348804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flipV="1">
            <a:off x="3727440" y="3225600"/>
            <a:ext cx="77760" cy="17604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 rot="16200000">
            <a:off x="3595320" y="3514680"/>
            <a:ext cx="273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flipH="1" flipV="1">
            <a:off x="3769920" y="2937960"/>
            <a:ext cx="34920" cy="28764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rot="18720600">
            <a:off x="3191760" y="323964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rot="1473600">
            <a:off x="3157560" y="2963520"/>
            <a:ext cx="357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mp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flipH="1" flipV="1">
            <a:off x="3597120" y="3241440"/>
            <a:ext cx="54000" cy="12996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 rot="16200000">
            <a:off x="3528360" y="3499560"/>
            <a:ext cx="2901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og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 flipH="1" flipV="1">
            <a:off x="3597120" y="3241440"/>
            <a:ext cx="7920" cy="9828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 rot="16200000">
            <a:off x="3486960" y="3443400"/>
            <a:ext cx="255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at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 flipH="1" flipV="1">
            <a:off x="3590640" y="3190680"/>
            <a:ext cx="6120" cy="5076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 flipH="1" flipV="1">
            <a:off x="3538440" y="3258720"/>
            <a:ext cx="28800" cy="13356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 rot="16204200">
            <a:off x="3422880" y="3506400"/>
            <a:ext cx="266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 flipH="1" flipV="1">
            <a:off x="3449520" y="3443040"/>
            <a:ext cx="22320" cy="5220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rot="16666800">
            <a:off x="3248280" y="3637800"/>
            <a:ext cx="30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ow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 flipV="1">
            <a:off x="3424320" y="3443400"/>
            <a:ext cx="25200" cy="6336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 rot="16200000">
            <a:off x="3310560" y="3651480"/>
            <a:ext cx="357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Sheep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 flipV="1">
            <a:off x="3449520" y="3259080"/>
            <a:ext cx="88920" cy="18432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 flipV="1">
            <a:off x="3538440" y="3190680"/>
            <a:ext cx="52560" cy="6804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 flipV="1">
            <a:off x="3591000" y="3080880"/>
            <a:ext cx="100080" cy="10980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 flipV="1">
            <a:off x="3691080" y="2937960"/>
            <a:ext cx="79200" cy="14292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 flipV="1">
            <a:off x="3770280" y="2566800"/>
            <a:ext cx="162000" cy="37116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 flipH="1" flipV="1">
            <a:off x="3928680" y="1942920"/>
            <a:ext cx="3240" cy="62388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 flipH="1" flipV="1">
            <a:off x="3389040" y="1541520"/>
            <a:ext cx="539640" cy="40176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 flipH="1" flipV="1">
            <a:off x="3153960" y="2939760"/>
            <a:ext cx="88920" cy="50940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 rot="16285800">
            <a:off x="2980080" y="3687120"/>
            <a:ext cx="503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flipH="1" flipV="1">
            <a:off x="3028680" y="3169800"/>
            <a:ext cx="74520" cy="40500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 rot="16115400">
            <a:off x="2901960" y="3756600"/>
            <a:ext cx="403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flipH="1" flipV="1">
            <a:off x="2841120" y="3560760"/>
            <a:ext cx="55800" cy="8568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 rot="16135800">
            <a:off x="2720880" y="380052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 flipV="1">
            <a:off x="2813040" y="3560760"/>
            <a:ext cx="28440" cy="9216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 rot="16237200">
            <a:off x="2666880" y="3760200"/>
            <a:ext cx="273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 flipH="1" flipV="1">
            <a:off x="2750760" y="3405240"/>
            <a:ext cx="90360" cy="15552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flipH="1" flipV="1">
            <a:off x="2689200" y="3603240"/>
            <a:ext cx="1440" cy="468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rot="16135800">
            <a:off x="2542680" y="376488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flipV="1">
            <a:off x="2685960" y="3603240"/>
            <a:ext cx="3240" cy="1908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rot="16258800">
            <a:off x="2486520" y="3780000"/>
            <a:ext cx="357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mp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flipH="1" flipV="1">
            <a:off x="2674800" y="3470400"/>
            <a:ext cx="14400" cy="13320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flipV="1">
            <a:off x="2570040" y="3506760"/>
            <a:ext cx="20880" cy="18576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 rot="17337000">
            <a:off x="2376000" y="3807000"/>
            <a:ext cx="2901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og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flipV="1">
            <a:off x="2419200" y="3506760"/>
            <a:ext cx="171720" cy="13176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 rot="17779800">
            <a:off x="2192760" y="3753720"/>
            <a:ext cx="30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ow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 flipV="1">
            <a:off x="2590920" y="3470040"/>
            <a:ext cx="83880" cy="3636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 flipV="1">
            <a:off x="2674800" y="3404880"/>
            <a:ext cx="76320" cy="6516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 flipV="1">
            <a:off x="2751120" y="3169800"/>
            <a:ext cx="277920" cy="23508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flipV="1">
            <a:off x="3029040" y="2939760"/>
            <a:ext cx="125280" cy="23004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flipH="1" flipV="1">
            <a:off x="3055680" y="2577960"/>
            <a:ext cx="98280" cy="36216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flipV="1">
            <a:off x="2544840" y="2908080"/>
            <a:ext cx="282600" cy="34596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 rot="17558400">
            <a:off x="2093040" y="3454920"/>
            <a:ext cx="439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ebrafish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flipV="1">
            <a:off x="2403360" y="2908440"/>
            <a:ext cx="424080" cy="36504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 rot="17866200">
            <a:off x="2307240" y="3372480"/>
            <a:ext cx="319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flipV="1">
            <a:off x="2827440" y="2577960"/>
            <a:ext cx="228600" cy="33048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 flipV="1">
            <a:off x="3056040" y="1976040"/>
            <a:ext cx="133200" cy="60156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 flipV="1">
            <a:off x="2230560" y="2804760"/>
            <a:ext cx="93600" cy="50652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 rot="16788000">
            <a:off x="1991880" y="3487680"/>
            <a:ext cx="403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 flipV="1">
            <a:off x="2035080" y="3025800"/>
            <a:ext cx="27000" cy="34272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 rot="16200000">
            <a:off x="1803600" y="3583080"/>
            <a:ext cx="447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Opossum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 flipH="1" flipV="1">
            <a:off x="1751040" y="3181320"/>
            <a:ext cx="22320" cy="20952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 rot="16200000">
            <a:off x="1587240" y="355860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 flipV="1">
            <a:off x="1563840" y="3181320"/>
            <a:ext cx="187200" cy="19224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 rot="19530000">
            <a:off x="1303920" y="3438360"/>
            <a:ext cx="266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 flipV="1">
            <a:off x="1751040" y="3049560"/>
            <a:ext cx="31680" cy="13176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 flipV="1">
            <a:off x="1444680" y="3052440"/>
            <a:ext cx="92160" cy="10620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 rot="19446000">
            <a:off x="1107000" y="324432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 flipV="1">
            <a:off x="1379520" y="3052440"/>
            <a:ext cx="157320" cy="468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1082520" y="3019320"/>
            <a:ext cx="273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 flipV="1">
            <a:off x="1536840" y="3049200"/>
            <a:ext cx="245880" cy="324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 flipV="1">
            <a:off x="1782720" y="3025800"/>
            <a:ext cx="279360" cy="2376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 flipV="1">
            <a:off x="2062080" y="2804760"/>
            <a:ext cx="262080" cy="22068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 flipV="1">
            <a:off x="2324160" y="2541600"/>
            <a:ext cx="41040" cy="26352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 flipV="1">
            <a:off x="1668600" y="2720520"/>
            <a:ext cx="214200" cy="4932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 rot="20728200">
            <a:off x="1245600" y="2786040"/>
            <a:ext cx="415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laev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1700280" y="2697120"/>
            <a:ext cx="182520" cy="2376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 rot="20937600">
            <a:off x="1186560" y="2704680"/>
            <a:ext cx="503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 flipV="1">
            <a:off x="1882800" y="2541600"/>
            <a:ext cx="482400" cy="17928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 flipV="1">
            <a:off x="2365200" y="2216160"/>
            <a:ext cx="276480" cy="32544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 flipV="1">
            <a:off x="1712880" y="2509560"/>
            <a:ext cx="122400" cy="8244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 rot="20912400">
            <a:off x="1141560" y="2629080"/>
            <a:ext cx="566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inbow trout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 flipV="1">
            <a:off x="1701720" y="2509560"/>
            <a:ext cx="133560" cy="4284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 rot="20958000">
            <a:off x="1086120" y="2569680"/>
            <a:ext cx="608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inbow trout TLR5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 flipV="1">
            <a:off x="1835280" y="2295360"/>
            <a:ext cx="417240" cy="21456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 flipV="1">
            <a:off x="1554120" y="2305080"/>
            <a:ext cx="335160" cy="21096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 rot="20944800">
            <a:off x="1217880" y="2502000"/>
            <a:ext cx="319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 flipV="1">
            <a:off x="1503360" y="2305080"/>
            <a:ext cx="385920" cy="7920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 rot="20975400">
            <a:off x="1132560" y="2385720"/>
            <a:ext cx="361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5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 flipV="1">
            <a:off x="1889280" y="2295000"/>
            <a:ext cx="363240" cy="972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 flipV="1">
            <a:off x="2262240" y="2214720"/>
            <a:ext cx="388800" cy="7920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 flipV="1">
            <a:off x="2641680" y="1976400"/>
            <a:ext cx="547560" cy="23976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 flipV="1">
            <a:off x="3189240" y="1541520"/>
            <a:ext cx="200160" cy="43488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 flipH="1" flipV="1">
            <a:off x="3139560" y="1038240"/>
            <a:ext cx="249480" cy="50328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 flipV="1">
            <a:off x="1854360" y="1352520"/>
            <a:ext cx="772920" cy="582480"/>
          </a:xfrm>
          <a:prstGeom prst="line">
            <a:avLst/>
          </a:prstGeom>
          <a:ln cap="sq" w="1584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 rot="19300200">
            <a:off x="1356480" y="2074680"/>
            <a:ext cx="538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1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 flipV="1">
            <a:off x="1481040" y="1326960"/>
            <a:ext cx="606600" cy="742680"/>
          </a:xfrm>
          <a:prstGeom prst="line">
            <a:avLst/>
          </a:prstGeom>
          <a:ln cap="sq" w="1584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 rot="19129800">
            <a:off x="1050120" y="2197080"/>
            <a:ext cx="474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ebrafish TLR1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 flipV="1">
            <a:off x="1100160" y="1704600"/>
            <a:ext cx="228600" cy="507960"/>
          </a:xfrm>
          <a:prstGeom prst="line">
            <a:avLst/>
          </a:prstGeom>
          <a:ln cap="sq" w="1584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 rot="18308400">
            <a:off x="714600" y="2403720"/>
            <a:ext cx="453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latypus TLR1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 flipV="1">
            <a:off x="770040" y="1816200"/>
            <a:ext cx="152280" cy="341280"/>
          </a:xfrm>
          <a:prstGeom prst="line">
            <a:avLst/>
          </a:prstGeom>
          <a:ln cap="sq" w="1584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 rot="18201000">
            <a:off x="525240" y="2272680"/>
            <a:ext cx="30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Bat TLR1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 flipV="1">
            <a:off x="469800" y="1804680"/>
            <a:ext cx="112680" cy="190440"/>
          </a:xfrm>
          <a:prstGeom prst="line">
            <a:avLst/>
          </a:prstGeom>
          <a:ln cap="sq" w="1584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45360" y="1979640"/>
            <a:ext cx="399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1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417600" y="1803240"/>
            <a:ext cx="164880" cy="1800"/>
          </a:xfrm>
          <a:prstGeom prst="line">
            <a:avLst/>
          </a:prstGeom>
          <a:ln cap="sq" w="1584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82440" y="1763640"/>
            <a:ext cx="3085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1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582480" y="1805040"/>
            <a:ext cx="339840" cy="11160"/>
          </a:xfrm>
          <a:prstGeom prst="line">
            <a:avLst/>
          </a:prstGeom>
          <a:ln cap="sq" w="1584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 flipV="1">
            <a:off x="922320" y="1704600"/>
            <a:ext cx="406440" cy="111240"/>
          </a:xfrm>
          <a:prstGeom prst="line">
            <a:avLst/>
          </a:prstGeom>
          <a:ln cap="sq" w="1584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 flipV="1">
            <a:off x="1328760" y="1329840"/>
            <a:ext cx="201600" cy="374760"/>
          </a:xfrm>
          <a:prstGeom prst="line">
            <a:avLst/>
          </a:prstGeom>
          <a:ln cap="sq" w="1584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 flipV="1">
            <a:off x="685800" y="1412640"/>
            <a:ext cx="130320" cy="42840"/>
          </a:xfrm>
          <a:prstGeom prst="line">
            <a:avLst/>
          </a:prstGeom>
          <a:ln cap="sq" w="1584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352080" y="1436760"/>
            <a:ext cx="3085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1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655560" y="1390680"/>
            <a:ext cx="160560" cy="22320"/>
          </a:xfrm>
          <a:prstGeom prst="line">
            <a:avLst/>
          </a:prstGeom>
          <a:ln cap="sq" w="1584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248760" y="1351080"/>
            <a:ext cx="399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1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 flipV="1">
            <a:off x="816120" y="1330200"/>
            <a:ext cx="714240" cy="82800"/>
          </a:xfrm>
          <a:prstGeom prst="line">
            <a:avLst/>
          </a:prstGeom>
          <a:ln cap="sq" w="1584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 flipV="1">
            <a:off x="1530360" y="1327320"/>
            <a:ext cx="557280" cy="2880"/>
          </a:xfrm>
          <a:prstGeom prst="line">
            <a:avLst/>
          </a:prstGeom>
          <a:ln cap="sq" w="1584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2087640" y="1327320"/>
            <a:ext cx="539640" cy="25200"/>
          </a:xfrm>
          <a:prstGeom prst="line">
            <a:avLst/>
          </a:prstGeom>
          <a:ln cap="sq" w="1584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 flipV="1">
            <a:off x="2627280" y="1037880"/>
            <a:ext cx="512640" cy="314280"/>
          </a:xfrm>
          <a:prstGeom prst="line">
            <a:avLst/>
          </a:prstGeom>
          <a:ln cap="sq" w="1584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 flipV="1">
            <a:off x="3139920" y="527040"/>
            <a:ext cx="115920" cy="51120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2962440" y="160200"/>
            <a:ext cx="293400" cy="3668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0" name=""/>
          <p:cNvGrpSpPr/>
          <p:nvPr/>
        </p:nvGrpSpPr>
        <p:grpSpPr>
          <a:xfrm>
            <a:off x="3488760" y="3074760"/>
            <a:ext cx="205200" cy="43920"/>
            <a:chOff x="3488760" y="3074760"/>
            <a:chExt cx="205200" cy="43920"/>
          </a:xfrm>
        </p:grpSpPr>
        <p:sp>
          <p:nvSpPr>
            <p:cNvPr id="221" name=""/>
            <p:cNvSpPr/>
            <p:nvPr/>
          </p:nvSpPr>
          <p:spPr>
            <a:xfrm flipV="1">
              <a:off x="3494160" y="3113640"/>
              <a:ext cx="4680" cy="2520"/>
            </a:xfrm>
            <a:prstGeom prst="line">
              <a:avLst/>
            </a:prstGeom>
            <a:ln cap="sq" w="15840">
              <a:solidFill>
                <a:srgbClr val="ff99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 flipV="1">
              <a:off x="3488760" y="3115440"/>
              <a:ext cx="10800" cy="3240"/>
            </a:xfrm>
            <a:prstGeom prst="line">
              <a:avLst/>
            </a:prstGeom>
            <a:ln cap="sq" w="15840">
              <a:solidFill>
                <a:srgbClr val="ff99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 flipV="1">
              <a:off x="3499560" y="3074760"/>
              <a:ext cx="194400" cy="40680"/>
            </a:xfrm>
            <a:prstGeom prst="line">
              <a:avLst/>
            </a:prstGeom>
            <a:ln cap="sq" w="15840">
              <a:solidFill>
                <a:srgbClr val="ff99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4" name=""/>
          <p:cNvSpPr/>
          <p:nvPr/>
        </p:nvSpPr>
        <p:spPr>
          <a:xfrm>
            <a:off x="6094080" y="25830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5887800" y="27939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6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5893920" y="26701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5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5837040" y="25765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5779800" y="24084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5601960" y="22050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5312880" y="19782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4870080" y="19940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4790880" y="35593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4873320" y="34383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6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4878000" y="32907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4978080" y="29923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5079600" y="27018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5105160" y="22939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4338360" y="19875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Arial"/>
              </a:rPr>
              <a:t>6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3990600" y="34545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4158720" y="31910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4284360" y="27939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4433400" y="23860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3811320" y="19461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3811320" y="25192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3654000" y="28764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3685680" y="31719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3507840" y="30146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3641400" y="29797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3612960" y="31971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3522240" y="31258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3457080" y="32194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3331800" y="33876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2836440" y="34750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2687400" y="35272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2598480" y="33973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2642760" y="33336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2949120" y="31021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3063600" y="28926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2941200" y="25178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2744280" y="28465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1541160" y="29638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1775880" y="31384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1723680" y="29638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1950840" y="29512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2242800" y="27446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6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1823760" y="26370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2383920" y="25272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1747440" y="24289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1875960" y="22176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2252160" y="22050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2572920" y="21304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3111120" y="18892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6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3285720" y="14986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766440" y="13287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533160" y="17240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860040" y="17240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1258560" y="16286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1476000" y="12463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2037960" y="12351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5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2582640" y="12574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3055680" y="9777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18T11:25:08Z</dcterms:created>
  <dc:creator>Nicholas David Temperley</dc:creator>
  <dc:description/>
  <dc:language>en-US</dc:language>
  <cp:lastModifiedBy>Nicholas David Temperley</cp:lastModifiedBy>
  <dcterms:modified xsi:type="dcterms:W3CDTF">2008-01-31T15:42:31Z</dcterms:modified>
  <cp:revision>31</cp:revision>
  <dc:subject/>
  <dc:title>Slide 1</dc:title>
</cp:coreProperties>
</file>